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8168" autoAdjust="0"/>
  </p:normalViewPr>
  <p:slideViewPr>
    <p:cSldViewPr snapToGrid="0">
      <p:cViewPr>
        <p:scale>
          <a:sx n="66" d="100"/>
          <a:sy n="66" d="100"/>
        </p:scale>
        <p:origin x="1764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0910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19200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575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14632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76198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09364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0231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7963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315206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0350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62244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393DAE-8E53-4500-995F-AECF631BB07E}" type="datetimeFigureOut">
              <a:rPr lang="zh-CN" altLang="en-US" smtClean="0"/>
              <a:t>2018/5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C603E1-798A-443D-AF84-2F18FEC692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1510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97233" y="218209"/>
            <a:ext cx="6465971" cy="950191"/>
          </a:xfrm>
        </p:spPr>
        <p:txBody>
          <a:bodyPr>
            <a:normAutofit fontScale="90000"/>
          </a:bodyPr>
          <a:lstStyle/>
          <a:p>
            <a:r>
              <a:rPr lang="en-US" altLang="zh-CN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en-US" altLang="zh-CN" sz="1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2 </a:t>
            </a:r>
            <a:r>
              <a:rPr lang="en-US" altLang="zh-CN" sz="18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etails </a:t>
            </a:r>
            <a:r>
              <a:rPr lang="en-US" altLang="zh-CN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of sampling site with site No., sampling data, river name, hydrological information, willow species (sampling number) and location of this study. </a:t>
            </a:r>
            <a:r>
              <a:rPr lang="en-US" altLang="zh-CN" sz="18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I </a:t>
            </a:r>
            <a:r>
              <a:rPr lang="en-US" altLang="zh-CN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and K river </a:t>
            </a:r>
            <a:r>
              <a:rPr lang="en-US" altLang="zh-CN" sz="18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represent </a:t>
            </a:r>
            <a:r>
              <a:rPr lang="en-US" altLang="zh-CN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Indigirka and </a:t>
            </a:r>
            <a:r>
              <a:rPr lang="en-US" altLang="zh-CN" sz="1800" kern="0" dirty="0" err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Kryvaya</a:t>
            </a:r>
            <a:r>
              <a:rPr lang="en-US" altLang="zh-CN" sz="1800" kern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 river</a:t>
            </a:r>
            <a:r>
              <a:rPr lang="en-US" altLang="zh-CN" sz="1800" kern="0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.</a:t>
            </a:r>
            <a:endParaRPr lang="zh-CN" altLang="en-US" sz="1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表格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4767502"/>
              </p:ext>
            </p:extLst>
          </p:nvPr>
        </p:nvGraphicFramePr>
        <p:xfrm>
          <a:off x="124662" y="1194718"/>
          <a:ext cx="6733338" cy="8472349"/>
        </p:xfrm>
        <a:graphic>
          <a:graphicData uri="http://schemas.openxmlformats.org/drawingml/2006/table">
            <a:tbl>
              <a:tblPr/>
              <a:tblGrid>
                <a:gridCol w="660198">
                  <a:extLst>
                    <a:ext uri="{9D8B030D-6E8A-4147-A177-3AD203B41FA5}">
                      <a16:colId xmlns:a16="http://schemas.microsoft.com/office/drawing/2014/main" val="27628052"/>
                    </a:ext>
                  </a:extLst>
                </a:gridCol>
                <a:gridCol w="704850">
                  <a:extLst>
                    <a:ext uri="{9D8B030D-6E8A-4147-A177-3AD203B41FA5}">
                      <a16:colId xmlns:a16="http://schemas.microsoft.com/office/drawing/2014/main" val="3601846651"/>
                    </a:ext>
                  </a:extLst>
                </a:gridCol>
                <a:gridCol w="529590">
                  <a:extLst>
                    <a:ext uri="{9D8B030D-6E8A-4147-A177-3AD203B41FA5}">
                      <a16:colId xmlns:a16="http://schemas.microsoft.com/office/drawing/2014/main" val="3981401412"/>
                    </a:ext>
                  </a:extLst>
                </a:gridCol>
                <a:gridCol w="1325880">
                  <a:extLst>
                    <a:ext uri="{9D8B030D-6E8A-4147-A177-3AD203B41FA5}">
                      <a16:colId xmlns:a16="http://schemas.microsoft.com/office/drawing/2014/main" val="2875120012"/>
                    </a:ext>
                  </a:extLst>
                </a:gridCol>
                <a:gridCol w="2419350">
                  <a:extLst>
                    <a:ext uri="{9D8B030D-6E8A-4147-A177-3AD203B41FA5}">
                      <a16:colId xmlns:a16="http://schemas.microsoft.com/office/drawing/2014/main" val="3651022939"/>
                    </a:ext>
                  </a:extLst>
                </a:gridCol>
                <a:gridCol w="506730">
                  <a:extLst>
                    <a:ext uri="{9D8B030D-6E8A-4147-A177-3AD203B41FA5}">
                      <a16:colId xmlns:a16="http://schemas.microsoft.com/office/drawing/2014/main" val="252358413"/>
                    </a:ext>
                  </a:extLst>
                </a:gridCol>
                <a:gridCol w="586740">
                  <a:extLst>
                    <a:ext uri="{9D8B030D-6E8A-4147-A177-3AD203B41FA5}">
                      <a16:colId xmlns:a16="http://schemas.microsoft.com/office/drawing/2014/main" val="1942019427"/>
                    </a:ext>
                  </a:extLst>
                </a:gridCol>
              </a:tblGrid>
              <a:tr h="27805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te </a:t>
                      </a:r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o.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9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ampling Date</a:t>
                      </a:r>
                      <a:endParaRPr lang="en-US" sz="9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ocation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etail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Dominant species composition (sampled number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at</a:t>
                      </a:r>
                      <a:r>
                        <a:rPr lang="en-US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（°）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1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on（°）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15033936"/>
                  </a:ext>
                </a:extLst>
              </a:tr>
              <a:tr h="614467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Boydom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15072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 sometimes </a:t>
                      </a:r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(87.5cm),</a:t>
                      </a: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 on land(52.5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 on land(52.5cm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3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</a:t>
                      </a:r>
                      <a:r>
                        <a:rPr lang="en-US" sz="8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  <a:endParaRPr lang="en-US" sz="800" b="0" i="1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64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1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 w="3175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0229916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I1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150729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ichardsonii (3), S. glauca (2), S. boganidensi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3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8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27051591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I2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9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alaxensis (5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33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4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75025862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I4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3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ichardsonii (2), S. boganidensis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62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9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81297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I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150725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ichardsonii (2), S. pulchra (3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62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3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81868177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glauca (1), S. boganidensis (3), S. pulchra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7428314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11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4), S. glauca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3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63257585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12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2), S. pulchra (3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34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06962733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13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2), S. pulchra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3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44625887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14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2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lchr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6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4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0301853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4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31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2), S. alaxensis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0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68110738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3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1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62521261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9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3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glauca, S. boganidensis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312512"/>
                  </a:ext>
                </a:extLst>
              </a:tr>
              <a:tr h="539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A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15080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 nearly flooded(67.5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 on land(52.5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 on land(31.5cm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7762733"/>
                  </a:ext>
                </a:extLst>
              </a:tr>
              <a:tr h="539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B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80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 sometimes flooded(70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 on land(52.5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 on land(50cm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1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37690516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Hill1,7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80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pulchra (1), S. richardsonii (1), S. glauca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30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73605026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KHill2,3,4,5,6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80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ll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hill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eptus, S. richardsonii (2), S. glauca (1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3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21804734"/>
                  </a:ext>
                </a:extLst>
              </a:tr>
              <a:tr h="2474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SVK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50729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te VK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etland, on land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5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5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lchr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3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2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4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3182897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1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160721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8) S. alaxensi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2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4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23181838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2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6), S. alaxensi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33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44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8021668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3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8), S. alaxensi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38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52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0233339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4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floode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7), S. alaxensis, S. pulchra (1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48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68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7206141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8), S. alaxensi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3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8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8184734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6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8), S. alaxensis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8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88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557925"/>
                  </a:ext>
                </a:extLst>
              </a:tr>
              <a:tr h="2474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VK-1, 2, </a:t>
                      </a:r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te VK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Wet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8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pulchr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2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2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4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2754316"/>
                  </a:ext>
                </a:extLst>
              </a:tr>
              <a:tr h="24747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VK-3, 4, 6, 7, </a:t>
                      </a:r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1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ite VK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arch forest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8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3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2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4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3268115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1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2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pulchra (2), S. boganidensis (6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3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5078769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2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2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7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4777187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I7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s-E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ichardsonii (1) S. pulchra (3), S. boganidensis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62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9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72236524"/>
                  </a:ext>
                </a:extLst>
              </a:tr>
              <a:tr h="539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A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 flooding(70.5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 on land(52.7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 on land(32.3cm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oganidensis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1),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3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5082299"/>
                  </a:ext>
                </a:extLst>
              </a:tr>
              <a:tr h="539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B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 flooding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 flooding(60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 flooded(66.2cm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/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lauc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1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5283424"/>
                  </a:ext>
                </a:extLst>
              </a:tr>
              <a:tr h="53992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Boydom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 flooding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 on land(52.7cm),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  on land(42.5cm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Transects, position a, b, c:</a:t>
                      </a:r>
                      <a:b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  <a:b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S. </a:t>
                      </a:r>
                      <a:r>
                        <a:rPr lang="en-US" sz="800" b="0" i="1" u="none" strike="noStrike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richardsonii</a:t>
                      </a:r>
                      <a:r>
                        <a:rPr lang="en-US" sz="800" b="0" i="1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64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15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9629395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ichardsonii (6), S. pulchra (2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6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6422489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4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pulchra (4), S. boganidensis (4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9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0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16573056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5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richardsonii (3), S. pulchra (5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7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11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425563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K7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3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ed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8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4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.23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0843664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Allaiha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 river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Flooding and on land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2), S. richardsonii (6), S. pulchra (3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2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30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6211101"/>
                  </a:ext>
                </a:extLst>
              </a:tr>
              <a:tr h="13498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SAllaiha-hill</a:t>
                      </a:r>
                      <a:r>
                        <a:rPr lang="zh-CN" altLang="en-US" sz="800" b="1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*</a:t>
                      </a:r>
                      <a:endParaRPr lang="en-US" sz="800" b="1" i="0" u="none" strike="noStrike" dirty="0">
                        <a:solidFill>
                          <a:srgbClr val="0070C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0160724</a:t>
                      </a:r>
                      <a:endParaRPr lang="en-US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ill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On hill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1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S. boganidensis (1), S. glauca (2), S. richardsonii (1)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.52 </a:t>
                      </a: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8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.28 </a:t>
                      </a:r>
                      <a:endParaRPr lang="en-US" altLang="zh-CN" sz="8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2803" marR="2803" marT="28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3892272"/>
                  </a:ext>
                </a:extLst>
              </a:tr>
            </a:tbl>
          </a:graphicData>
        </a:graphic>
      </p:graphicFrame>
      <p:sp>
        <p:nvSpPr>
          <p:cNvPr id="3" name="矩形 2"/>
          <p:cNvSpPr/>
          <p:nvPr/>
        </p:nvSpPr>
        <p:spPr>
          <a:xfrm>
            <a:off x="105612" y="9632430"/>
            <a:ext cx="6908800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000" dirty="0" smtClean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he </a:t>
            </a:r>
            <a:r>
              <a:rPr lang="en-US" altLang="zh-CN" sz="1000" dirty="0">
                <a:solidFill>
                  <a:srgbClr val="0070C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te No. in bold with asterisk is not shown in Figure 2. </a:t>
            </a:r>
            <a:endParaRPr lang="zh-CN" altLang="en-US" sz="1000" dirty="0">
              <a:solidFill>
                <a:srgbClr val="0070C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06895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7</TotalTime>
  <Words>943</Words>
  <Application>Microsoft Office PowerPoint</Application>
  <PresentationFormat>A4 纸张(210x297 毫米)</PresentationFormat>
  <Paragraphs>27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Table A2 Details of sampling site with site No., sampling data, river name, hydrological information, willow species (sampling number) and location of this study. I and K river represent Indigirka and Kryvaya river.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 Map (Material part)</dc:title>
  <dc:creator>Rubing Fan</dc:creator>
  <cp:lastModifiedBy>Rubing Fan</cp:lastModifiedBy>
  <cp:revision>55</cp:revision>
  <dcterms:created xsi:type="dcterms:W3CDTF">2017-04-27T04:52:39Z</dcterms:created>
  <dcterms:modified xsi:type="dcterms:W3CDTF">2018-05-26T13:23:55Z</dcterms:modified>
</cp:coreProperties>
</file>